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799"/>
    <p:restoredTop sz="94726"/>
  </p:normalViewPr>
  <p:slideViewPr>
    <p:cSldViewPr snapToGrid="0" snapToObjects="1">
      <p:cViewPr varScale="1">
        <p:scale>
          <a:sx n="102" d="100"/>
          <a:sy n="102" d="100"/>
        </p:scale>
        <p:origin x="3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1C128E-60C8-E246-9FB7-0CE34ACC562F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DCA35A-9597-5A43-96EE-DF3C77D2A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496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DCA35A-9597-5A43-96EE-DF3C77D2AF3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493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480BF-E291-5843-84FE-82C64FFA1E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124C319-B0A4-E640-BD93-545D47064F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8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2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6205D4-7EA9-274B-8833-D993EF69E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C84DAF-B2E9-0E49-89B6-ECABF8EA8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96916-7454-0C48-927A-65ED7F7DF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404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A9F80-3CFA-FA41-A987-44778F7B01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578073-4A40-3F40-9F67-F2832D1C50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E9F9B4-3153-F74D-937F-56D44142D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348284-7660-5F46-A8B7-01494580E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77A1BC-DBD8-F848-88F5-A7E89D803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592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E23A7D5-E12D-1042-82F0-404A516577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67A987-0BD8-BD4F-B4F8-A850AF630E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0F8B2D-30E5-B54D-AF70-D0DA77F37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CCC76F-8424-6F42-8FCE-65EFA67E1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F8056-897C-AB41-A525-E5AF9EF4F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264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36B88-62F0-4440-842A-966772A663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5D633F-658F-4744-AA35-4DA8BAD938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48DA86-13BA-EA40-A556-D43BEFD32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890EE-3499-874B-808B-92E32655D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04057A-4E4D-0642-A5C9-9D89E7390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294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6DB29D-EB18-294A-B46E-5A8018FD42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4C9D40-2805-4A4E-BB3C-3058A61A2D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59CEB-DD6A-B345-A14C-6682D5E17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447105-82B3-B04F-94EF-E372D58AC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88999B-5680-874E-BE50-3C2869D88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763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68619F-CA15-F746-A6B6-F3C390A80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39E845-E436-464B-892F-7304EBAF0E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0CAE78-B842-F84C-9D55-C083BA91B6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D5327F-C546-D844-B663-706FBFE43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18B1F8-8B15-6649-BCFA-1136C6BF4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93D51F-5EF2-A14D-AA18-F9D9687F6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188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EEC982-429C-2841-9FCF-C86D9F01DA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84FB6A-B2A2-EC45-8C30-6204C7374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79805E-A853-BC4E-9459-E42B8E752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4735EB-0F62-C240-994A-FCDD2F705B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35D6EC-E92E-1644-84DB-D69463C1EC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50968A-2AC8-9445-8808-4F11D987B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E3F5A7-15D4-E643-BE24-011EF10A7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045C5F-B90F-7246-95AC-10799F91D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141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77A512-9B6E-D14B-B85D-56905092C7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BD3358-0AEB-D244-AB46-8D9A82209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F26D40-0E74-C841-A183-81B2F4CB0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426F01-FCF1-B64A-863C-6FF28C517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80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32822A-0E20-FB4E-BDFB-58CBA82F4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5160B7-2539-1D46-A7F6-541A5633D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A03869-1564-A54F-A101-D3C94026B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561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502AB-84F5-C04F-864C-FC8D48956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2067EA-5801-074F-B31F-AE2E5274F6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64684D-4A11-9941-982C-244364490E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664EB3-02E1-9E43-B4C3-C9E40D172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850378-9867-DA47-9B4B-808EE1A80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CE0414-E248-FC47-A07F-F411EB7D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093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561BCE-9ABA-F944-838E-FD3F8DFCF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FBD2EA-9154-BC4A-AF62-9F7B33B241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828E29-DA59-A540-B5DE-FC4C7CAEE8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86B418-1354-1044-9D03-90E0F6B22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4A10A4-D448-2042-8F70-678416FD1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74CE60-A509-BD4F-A6FB-2D709F49E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802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F3AB07-BD8F-224D-9040-672B759816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22F7C1-6774-4243-BC5C-7863A9E59B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85AF3-2BCC-5A40-B6BD-479DC1873D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38B768-CE65-874D-8A96-266F75B2C386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B7A629-1CAF-0941-88B0-FCB34B26E7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80562-1268-2D4F-9E2E-3B8FDC38F6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BB9C5-11E6-1B47-9850-88EF00ED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22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6AF8BE2F-128E-4F47-BC69-F984568AAEF4}"/>
              </a:ext>
            </a:extLst>
          </p:cNvPr>
          <p:cNvSpPr/>
          <p:nvPr/>
        </p:nvSpPr>
        <p:spPr>
          <a:xfrm>
            <a:off x="749180" y="786447"/>
            <a:ext cx="3554463" cy="2215381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5D3AB3FE-C292-BB40-80C1-D9324E3D4DD2}"/>
              </a:ext>
            </a:extLst>
          </p:cNvPr>
          <p:cNvSpPr/>
          <p:nvPr/>
        </p:nvSpPr>
        <p:spPr>
          <a:xfrm>
            <a:off x="749180" y="3140123"/>
            <a:ext cx="3554463" cy="2215381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F2DA21A7-9716-934C-A7C7-75FA0BA740DA}"/>
              </a:ext>
            </a:extLst>
          </p:cNvPr>
          <p:cNvSpPr/>
          <p:nvPr/>
        </p:nvSpPr>
        <p:spPr>
          <a:xfrm>
            <a:off x="4534712" y="786449"/>
            <a:ext cx="3390100" cy="2215379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F0A8D60A-F49C-1849-880B-9A42E821C493}"/>
              </a:ext>
            </a:extLst>
          </p:cNvPr>
          <p:cNvSpPr/>
          <p:nvPr/>
        </p:nvSpPr>
        <p:spPr>
          <a:xfrm>
            <a:off x="8159261" y="786448"/>
            <a:ext cx="3290185" cy="2215380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887F30F2-0F1C-274B-B72D-CE475FEA9DA7}"/>
              </a:ext>
            </a:extLst>
          </p:cNvPr>
          <p:cNvSpPr/>
          <p:nvPr/>
        </p:nvSpPr>
        <p:spPr>
          <a:xfrm>
            <a:off x="4534712" y="3137435"/>
            <a:ext cx="3390099" cy="2215381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DBEFB3A7-DD13-FA4A-B86C-94DAAB1C210A}"/>
              </a:ext>
            </a:extLst>
          </p:cNvPr>
          <p:cNvSpPr/>
          <p:nvPr/>
        </p:nvSpPr>
        <p:spPr>
          <a:xfrm>
            <a:off x="8159262" y="3137436"/>
            <a:ext cx="3164486" cy="2216058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77204759-B6DD-D645-B3EC-8CA5F8A09125}"/>
              </a:ext>
            </a:extLst>
          </p:cNvPr>
          <p:cNvSpPr/>
          <p:nvPr/>
        </p:nvSpPr>
        <p:spPr>
          <a:xfrm>
            <a:off x="1447641" y="5434769"/>
            <a:ext cx="9492108" cy="569424"/>
          </a:xfrm>
          <a:prstGeom prst="rightArrow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4117D2-F687-ED4E-801D-4D259FBA710A}"/>
              </a:ext>
            </a:extLst>
          </p:cNvPr>
          <p:cNvSpPr txBox="1"/>
          <p:nvPr/>
        </p:nvSpPr>
        <p:spPr>
          <a:xfrm>
            <a:off x="1773872" y="5539353"/>
            <a:ext cx="8475182" cy="3163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enstrual control/suppress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007C2B-BC1A-9E4D-9D72-6211778B0ECB}"/>
              </a:ext>
            </a:extLst>
          </p:cNvPr>
          <p:cNvSpPr txBox="1"/>
          <p:nvPr/>
        </p:nvSpPr>
        <p:spPr>
          <a:xfrm>
            <a:off x="832403" y="482357"/>
            <a:ext cx="3009775" cy="3163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e-operativ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C93D34-E5D0-CF49-80F3-C66FD13FB8BD}"/>
              </a:ext>
            </a:extLst>
          </p:cNvPr>
          <p:cNvSpPr txBox="1"/>
          <p:nvPr/>
        </p:nvSpPr>
        <p:spPr>
          <a:xfrm>
            <a:off x="4630750" y="482357"/>
            <a:ext cx="3009775" cy="3163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eri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/Intra-operativ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B47EC8F-22D8-4848-ADA4-93FA15AE0113}"/>
              </a:ext>
            </a:extLst>
          </p:cNvPr>
          <p:cNvSpPr txBox="1"/>
          <p:nvPr/>
        </p:nvSpPr>
        <p:spPr>
          <a:xfrm>
            <a:off x="8310761" y="482357"/>
            <a:ext cx="3009775" cy="3163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ost-operativ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D4879BF-68CB-AF45-A59B-B2CC670B3B9E}"/>
              </a:ext>
            </a:extLst>
          </p:cNvPr>
          <p:cNvSpPr txBox="1"/>
          <p:nvPr/>
        </p:nvSpPr>
        <p:spPr>
          <a:xfrm rot="16200000">
            <a:off x="-897793" y="1847271"/>
            <a:ext cx="2459064" cy="314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emostati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F64EB69-0412-C942-BF89-CB8FC118D747}"/>
              </a:ext>
            </a:extLst>
          </p:cNvPr>
          <p:cNvSpPr txBox="1"/>
          <p:nvPr/>
        </p:nvSpPr>
        <p:spPr>
          <a:xfrm rot="16200000">
            <a:off x="-606042" y="4080948"/>
            <a:ext cx="2056514" cy="3142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terin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2AC9BB9-28F1-814F-9D15-CCC9A2BE9921}"/>
              </a:ext>
            </a:extLst>
          </p:cNvPr>
          <p:cNvSpPr txBox="1"/>
          <p:nvPr/>
        </p:nvSpPr>
        <p:spPr>
          <a:xfrm>
            <a:off x="896124" y="3179288"/>
            <a:ext cx="3291947" cy="2087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tient counseling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Surgical consents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Ultrasound</a:t>
            </a:r>
          </a:p>
          <a:p>
            <a:pPr marL="285750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ule out structural abnormalities</a:t>
            </a:r>
          </a:p>
          <a:p>
            <a:pPr marL="285750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ssess uterine size to guide IUD selection</a:t>
            </a:r>
          </a:p>
          <a:p>
            <a:pPr marL="742950" lvl="1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2 mg LNG (32 x 32mm) </a:t>
            </a:r>
          </a:p>
          <a:p>
            <a:pPr marL="742950" lvl="1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9.5 mg LNG (28 x 30mm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AE35653-0C9E-BA41-B21E-A9AFA0EB3A8C}"/>
              </a:ext>
            </a:extLst>
          </p:cNvPr>
          <p:cNvSpPr txBox="1"/>
          <p:nvPr/>
        </p:nvSpPr>
        <p:spPr>
          <a:xfrm>
            <a:off x="951496" y="1005340"/>
            <a:ext cx="2888446" cy="2087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agnostic lab assessmen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    CBC, ferritin, iron, TIBC, UPT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cedural protocol</a:t>
            </a:r>
          </a:p>
          <a:p>
            <a:pPr marL="285750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lection of prophylactic treatment</a:t>
            </a:r>
          </a:p>
          <a:p>
            <a:pPr marL="285750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issemination to team (including anesthesia)</a:t>
            </a:r>
          </a:p>
          <a:p>
            <a:pPr marL="285750" indent="-285750">
              <a:buFontTx/>
              <a:buChar char="-"/>
            </a:pP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95FFA9-5364-7F43-AD25-ACF41323DEF5}"/>
              </a:ext>
            </a:extLst>
          </p:cNvPr>
          <p:cNvSpPr txBox="1"/>
          <p:nvPr/>
        </p:nvSpPr>
        <p:spPr>
          <a:xfrm>
            <a:off x="4726074" y="998249"/>
            <a:ext cx="2758737" cy="16450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ype and Cross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e-procedure infusion of hemostatic agent /blood product</a:t>
            </a:r>
          </a:p>
          <a:p>
            <a:pPr marL="742950" lvl="1" indent="-285750">
              <a:buFontTx/>
              <a:buChar char="-"/>
            </a:pP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B94C68E-2C3D-2E45-AA02-B45ACE03201B}"/>
              </a:ext>
            </a:extLst>
          </p:cNvPr>
          <p:cNvSpPr txBox="1"/>
          <p:nvPr/>
        </p:nvSpPr>
        <p:spPr>
          <a:xfrm>
            <a:off x="8392346" y="892924"/>
            <a:ext cx="2926661" cy="2087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tinuation of oral antifibrinolytic therapy</a:t>
            </a:r>
          </a:p>
          <a:p>
            <a:pPr lvl="1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mmediately post-op x 5-7            days, and for unscheduled bleeding</a:t>
            </a:r>
          </a:p>
          <a:p>
            <a:pPr lvl="1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current use of OCP for 1-3 months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D8F1AAF-D302-A848-9314-E5D79410E907}"/>
              </a:ext>
            </a:extLst>
          </p:cNvPr>
          <p:cNvSpPr txBox="1"/>
          <p:nvPr/>
        </p:nvSpPr>
        <p:spPr>
          <a:xfrm>
            <a:off x="8509853" y="3158021"/>
            <a:ext cx="2618803" cy="1423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-4 week post procedure follow up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leeding profile assessment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PBA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2AC9BB9-28F1-814F-9D15-CCC9A2BE9921}"/>
              </a:ext>
            </a:extLst>
          </p:cNvPr>
          <p:cNvSpPr txBox="1"/>
          <p:nvPr/>
        </p:nvSpPr>
        <p:spPr>
          <a:xfrm>
            <a:off x="4857969" y="3165110"/>
            <a:ext cx="274674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Ultrasound availability and intraoperative guidanc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ed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elected device availability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Tx/>
              <a:buChar char="-"/>
            </a:pP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2899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69</TotalTime>
  <Words>128</Words>
  <Application>Microsoft Office PowerPoint</Application>
  <PresentationFormat>Widescreen</PresentationFormat>
  <Paragraphs>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Cygan</dc:creator>
  <cp:lastModifiedBy>Wright, Tonya</cp:lastModifiedBy>
  <cp:revision>25</cp:revision>
  <dcterms:created xsi:type="dcterms:W3CDTF">2021-09-24T13:24:14Z</dcterms:created>
  <dcterms:modified xsi:type="dcterms:W3CDTF">2024-11-13T17:49:01Z</dcterms:modified>
</cp:coreProperties>
</file>